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295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539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59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370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968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205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285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654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641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460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90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216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B536F-1791-48A0-A774-7EB1211A8A50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BD1E1-C028-4B3D-AC19-4FD7851DF6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985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>
            <a:extLst>
              <a:ext uri="{FF2B5EF4-FFF2-40B4-BE49-F238E27FC236}">
                <a16:creationId xmlns:a16="http://schemas.microsoft.com/office/drawing/2014/main" id="{C9B672F5-26C3-3440-9DC0-D69369D668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2947" y="576662"/>
            <a:ext cx="591210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st of primers used for genotyping and gene expression analysis in murine cells and tissues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F598C58-9503-C744-B57D-14AD0792DD96}"/>
              </a:ext>
            </a:extLst>
          </p:cNvPr>
          <p:cNvGraphicFramePr>
            <a:graphicFrameLocks noGrp="1"/>
          </p:cNvGraphicFramePr>
          <p:nvPr/>
        </p:nvGraphicFramePr>
        <p:xfrm>
          <a:off x="472947" y="1312573"/>
          <a:ext cx="5865452" cy="589227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91577">
                  <a:extLst>
                    <a:ext uri="{9D8B030D-6E8A-4147-A177-3AD203B41FA5}">
                      <a16:colId xmlns:a16="http://schemas.microsoft.com/office/drawing/2014/main" val="3567047409"/>
                    </a:ext>
                  </a:extLst>
                </a:gridCol>
                <a:gridCol w="1163781">
                  <a:extLst>
                    <a:ext uri="{9D8B030D-6E8A-4147-A177-3AD203B41FA5}">
                      <a16:colId xmlns:a16="http://schemas.microsoft.com/office/drawing/2014/main" val="1254923930"/>
                    </a:ext>
                  </a:extLst>
                </a:gridCol>
                <a:gridCol w="714895">
                  <a:extLst>
                    <a:ext uri="{9D8B030D-6E8A-4147-A177-3AD203B41FA5}">
                      <a16:colId xmlns:a16="http://schemas.microsoft.com/office/drawing/2014/main" val="4082827761"/>
                    </a:ext>
                  </a:extLst>
                </a:gridCol>
                <a:gridCol w="1853738">
                  <a:extLst>
                    <a:ext uri="{9D8B030D-6E8A-4147-A177-3AD203B41FA5}">
                      <a16:colId xmlns:a16="http://schemas.microsoft.com/office/drawing/2014/main" val="507171409"/>
                    </a:ext>
                  </a:extLst>
                </a:gridCol>
                <a:gridCol w="1741461">
                  <a:extLst>
                    <a:ext uri="{9D8B030D-6E8A-4147-A177-3AD203B41FA5}">
                      <a16:colId xmlns:a16="http://schemas.microsoft.com/office/drawing/2014/main" val="1066879202"/>
                    </a:ext>
                  </a:extLst>
                </a:gridCol>
              </a:tblGrid>
              <a:tr h="214345"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nam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bol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2926122079"/>
                  </a:ext>
                </a:extLst>
              </a:tr>
              <a:tr h="214345">
                <a:tc rowSpan="4">
                  <a:txBody>
                    <a:bodyPr/>
                    <a:lstStyle/>
                    <a:p>
                      <a:pPr marL="71755" marR="7175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otyping</a:t>
                      </a:r>
                    </a:p>
                  </a:txBody>
                  <a:tcPr marL="48228" marR="48228" marT="0" marB="0" vert="vert27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PAR⍺ 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PAR⍺ 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AAGTTGCAGGAGGGGATT GTG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ATTTCGGTAGCAGGTAGTCTT 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940729333"/>
                  </a:ext>
                </a:extLst>
              </a:tr>
              <a:tr h="2965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kb DMP1 cre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MP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GCCTTTCTCTCCACAGGT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TGTCCATCAGGTTCTTGC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1514303401"/>
                  </a:ext>
                </a:extLst>
              </a:tr>
              <a:tr h="2965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PAR⍺ fl/fl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PAR⍺ fl/fl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GTACTTTGTAGACATCTGAGAGGCG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GGTACCGTGGACTCAGAGCTAG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4248863149"/>
                  </a:ext>
                </a:extLst>
              </a:tr>
              <a:tr h="2143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on-4 deletion in OT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T PPAR⍺ deletion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AGCAGCCAGCTCTGTGTTGAGC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GGTACCGTGGACTCAGAGCTAG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3980995305"/>
                  </a:ext>
                </a:extLst>
              </a:tr>
              <a:tr h="312929">
                <a:tc rowSpan="11">
                  <a:txBody>
                    <a:bodyPr/>
                    <a:lstStyle/>
                    <a:p>
                      <a:pPr marL="71755" marR="7175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e expression analysis</a:t>
                      </a:r>
                    </a:p>
                  </a:txBody>
                  <a:tcPr marL="48228" marR="48228" marT="0" marB="0" vert="vert27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roxisome proliferator activated receptor-alpha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par</a:t>
                      </a: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⍺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CCTGAGGACAGGCACATT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CCCAGGTCTGAGAGGATG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2480467131"/>
                  </a:ext>
                </a:extLst>
              </a:tr>
              <a:tr h="2143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l-less homeobox 5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lx5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CAGGAGTGTTTGACAGAAGAGT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GAACGGAGCTTGGA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289869525"/>
                  </a:ext>
                </a:extLst>
              </a:tr>
              <a:tr h="27610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rix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x</a:t>
                      </a:r>
                      <a:endParaRPr lang="en-US" sz="90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2439553679"/>
                  </a:ext>
                </a:extLst>
              </a:tr>
              <a:tr h="290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calcin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cn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CCCTGAGTCTGACAAA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GGAGTCTGTTCACTACCTT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236719592"/>
                  </a:ext>
                </a:extLst>
              </a:tr>
              <a:tr h="2992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ty acid binding protein 4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abp4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TGGAATTCGATGAAATCA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ATCTAGGGTTATGA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336462715"/>
                  </a:ext>
                </a:extLst>
              </a:tr>
              <a:tr h="2992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6 antigen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36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CACCACATATCTACCAAA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CCAAACTGAGGAATGG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116135516"/>
                  </a:ext>
                </a:extLst>
              </a:tr>
              <a:tr h="2992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necrosis factor (ligand), member 11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nkl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CTGCCAGCATCCCA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AGCCTCGATCGTGG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17803705"/>
                  </a:ext>
                </a:extLst>
              </a:tr>
              <a:tr h="2992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death-inducing DFFA-like effector A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idea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 GGG ACA GAA ATG GAC AC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 AGA CAG CCG AGG AAG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78261998"/>
                  </a:ext>
                </a:extLst>
              </a:tr>
              <a:tr h="2992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 domain containing 16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dm16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AACTTTCCCCACTCCCTCTA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CAGCCTTGACCAGCAA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892583142"/>
                  </a:ext>
                </a:extLst>
              </a:tr>
              <a:tr h="2992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coupling protein 1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cp1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TGGTGAACCCGACAACT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TCCGGCTGAGAAGATCTTG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171689414"/>
                  </a:ext>
                </a:extLst>
              </a:tr>
              <a:tr h="428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iodinase, iodothyronine 2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o2</a:t>
                      </a: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TGACCCCTTTGGTTTCC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 CCC ATT ATC CCT TTT CC</a:t>
                      </a: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04393104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39190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</TotalTime>
  <Words>152</Words>
  <Application>Microsoft Office PowerPoint</Application>
  <PresentationFormat>Letter Paper (8.5x11 in)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eckac@outlook.com</dc:creator>
  <cp:lastModifiedBy>bleckac@outlook.com</cp:lastModifiedBy>
  <cp:revision>2</cp:revision>
  <dcterms:created xsi:type="dcterms:W3CDTF">2023-01-16T03:23:12Z</dcterms:created>
  <dcterms:modified xsi:type="dcterms:W3CDTF">2023-03-12T01:50:45Z</dcterms:modified>
</cp:coreProperties>
</file>